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AA348-6E30-4E76-B290-DA92EBD311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3A840-781E-4E7E-BC4F-541590874F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78412-3B72-45B3-8E1D-4F40B35AD9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93882-00AB-4AC0-85F0-C27E5F9874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A0A8D-5E8F-4B33-94BB-94450F8B12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99A0C-E15B-4E34-BFA1-B4B764CC18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E01BD-B31C-4A72-8F74-F6D0F1C696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746C2-12EB-4E6E-B76D-704C53C1E7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608B7-777E-4940-8E67-240AD68A46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CB8A7-7A46-430D-A0F9-A678EDF5F5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5DD39-7175-4BFE-A4A3-559E3C6593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1118B-9D5B-4EB7-9180-1ECA6415EC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31DFC5-4456-4FA9-8D0F-35380569373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414360" y="522360"/>
            <a:ext cx="98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表 2" descr=""/>
          <p:cNvPicPr/>
          <p:nvPr/>
        </p:nvPicPr>
        <p:blipFill>
          <a:blip r:embed="rId1"/>
          <a:stretch/>
        </p:blipFill>
        <p:spPr>
          <a:xfrm>
            <a:off x="2011320" y="1395360"/>
            <a:ext cx="3494160" cy="1944720"/>
          </a:xfrm>
          <a:prstGeom prst="rect">
            <a:avLst/>
          </a:prstGeom>
          <a:ln w="0">
            <a:noFill/>
          </a:ln>
        </p:spPr>
      </p:pic>
      <p:sp>
        <p:nvSpPr>
          <p:cNvPr id="43" name="矩形 3"/>
          <p:cNvSpPr/>
          <p:nvPr/>
        </p:nvSpPr>
        <p:spPr>
          <a:xfrm>
            <a:off x="157320" y="3348000"/>
            <a:ext cx="6421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generated LL/2 cells expressing RIP3 (LL/2-RIP3) or vector (LL/2-Vector) showed similar proliferation rates. LL/2 cells were seeded into 96-well. Cell viability was determined by measuring ATP levels every 24 hour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4:42Z</dcterms:modified>
  <cp:revision>423</cp:revision>
  <dc:subject/>
  <dc:title>幻灯片 1</dc:title>
</cp:coreProperties>
</file>